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93" r:id="rId2"/>
  </p:sldIdLst>
  <p:sldSz cx="6858000" cy="9144000" type="screen4x3"/>
  <p:notesSz cx="7102475" cy="93884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MOU" lastIdx="1" clrIdx="0">
    <p:extLst>
      <p:ext uri="{19B8F6BF-5375-455C-9EA6-DF929625EA0E}">
        <p15:presenceInfo xmlns:p15="http://schemas.microsoft.com/office/powerpoint/2012/main" userId="Microsoft Office Us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FF"/>
    <a:srgbClr val="FF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E7CC325-4795-4849-9191-356D33AB4AE7}" v="3" dt="2022-07-05T20:26:31.32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105" autoAdjust="0"/>
    <p:restoredTop sz="97459" autoAdjust="0"/>
  </p:normalViewPr>
  <p:slideViewPr>
    <p:cSldViewPr snapToGrid="0" snapToObjects="1">
      <p:cViewPr varScale="1">
        <p:scale>
          <a:sx n="83" d="100"/>
          <a:sy n="83" d="100"/>
        </p:scale>
        <p:origin x="3450" y="120"/>
      </p:cViewPr>
      <p:guideLst/>
    </p:cSldViewPr>
  </p:slideViewPr>
  <p:outlineViewPr>
    <p:cViewPr>
      <p:scale>
        <a:sx n="33" d="100"/>
        <a:sy n="33" d="100"/>
      </p:scale>
      <p:origin x="0" y="-3852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aurav Choudhary" userId="3592bda5-e2cd-48fa-994d-b8b90cf05d8d" providerId="ADAL" clId="{A62BAEF8-C93E-4FC1-990A-6734330C3689}"/>
    <pc:docChg chg="modSld">
      <pc:chgData name="Gaurav Choudhary" userId="3592bda5-e2cd-48fa-994d-b8b90cf05d8d" providerId="ADAL" clId="{A62BAEF8-C93E-4FC1-990A-6734330C3689}" dt="2022-07-06T17:26:03.375" v="34" actId="20577"/>
      <pc:docMkLst>
        <pc:docMk/>
      </pc:docMkLst>
      <pc:sldChg chg="modSp mod">
        <pc:chgData name="Gaurav Choudhary" userId="3592bda5-e2cd-48fa-994d-b8b90cf05d8d" providerId="ADAL" clId="{A62BAEF8-C93E-4FC1-990A-6734330C3689}" dt="2022-07-06T17:26:03.375" v="34" actId="20577"/>
        <pc:sldMkLst>
          <pc:docMk/>
          <pc:sldMk cId="3354599560" sldId="293"/>
        </pc:sldMkLst>
        <pc:spChg chg="mod">
          <ac:chgData name="Gaurav Choudhary" userId="3592bda5-e2cd-48fa-994d-b8b90cf05d8d" providerId="ADAL" clId="{A62BAEF8-C93E-4FC1-990A-6734330C3689}" dt="2022-07-06T17:26:03.375" v="34" actId="20577"/>
          <ac:spMkLst>
            <pc:docMk/>
            <pc:sldMk cId="3354599560" sldId="293"/>
            <ac:spMk id="2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469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2725" y="0"/>
            <a:ext cx="3078163" cy="469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883D82-A14A-8C4F-8652-DFE614C33BF5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73163"/>
            <a:ext cx="2378075" cy="31686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613" y="4518025"/>
            <a:ext cx="5683250" cy="36972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8575"/>
            <a:ext cx="3078163" cy="469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2725" y="8918575"/>
            <a:ext cx="3078163" cy="469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A61649-5B0B-4341-9D03-3DD056470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538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402-CD35-1240-A2B6-6ED5AE23E6DE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632DA-D9D3-D64F-B008-5BAB0AFA5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680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402-CD35-1240-A2B6-6ED5AE23E6DE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632DA-D9D3-D64F-B008-5BAB0AFA5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8186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402-CD35-1240-A2B6-6ED5AE23E6DE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632DA-D9D3-D64F-B008-5BAB0AFA5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9298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402-CD35-1240-A2B6-6ED5AE23E6DE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632DA-D9D3-D64F-B008-5BAB0AFA5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546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402-CD35-1240-A2B6-6ED5AE23E6DE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632DA-D9D3-D64F-B008-5BAB0AFA5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39130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402-CD35-1240-A2B6-6ED5AE23E6DE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632DA-D9D3-D64F-B008-5BAB0AFA5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247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402-CD35-1240-A2B6-6ED5AE23E6DE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632DA-D9D3-D64F-B008-5BAB0AFA5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508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402-CD35-1240-A2B6-6ED5AE23E6DE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632DA-D9D3-D64F-B008-5BAB0AFA5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1556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402-CD35-1240-A2B6-6ED5AE23E6DE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632DA-D9D3-D64F-B008-5BAB0AFA5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7775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402-CD35-1240-A2B6-6ED5AE23E6DE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632DA-D9D3-D64F-B008-5BAB0AFA5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051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402-CD35-1240-A2B6-6ED5AE23E6DE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632DA-D9D3-D64F-B008-5BAB0AFA5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668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69402-CD35-1240-A2B6-6ED5AE23E6DE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9632DA-D9D3-D64F-B008-5BAB0AFA5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581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512360" y="-25960"/>
            <a:ext cx="5915025" cy="614923"/>
          </a:xfrm>
        </p:spPr>
        <p:txBody>
          <a:bodyPr>
            <a:normAutofit/>
          </a:bodyPr>
          <a:lstStyle/>
          <a:p>
            <a:pPr algn="ctr"/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Supplementary File 1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: Patient samples</a:t>
            </a:r>
          </a:p>
        </p:txBody>
      </p:sp>
      <p:graphicFrame>
        <p:nvGraphicFramePr>
          <p:cNvPr id="5" name="Content Placeholder 4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688302990"/>
              </p:ext>
            </p:extLst>
          </p:nvPr>
        </p:nvGraphicFramePr>
        <p:xfrm>
          <a:off x="147396" y="588963"/>
          <a:ext cx="5915025" cy="2113598"/>
        </p:xfrm>
        <a:graphic>
          <a:graphicData uri="http://schemas.openxmlformats.org/drawingml/2006/table">
            <a:tbl>
              <a:tblPr/>
              <a:tblGrid>
                <a:gridCol w="903481">
                  <a:extLst>
                    <a:ext uri="{9D8B030D-6E8A-4147-A177-3AD203B41FA5}">
                      <a16:colId xmlns:a16="http://schemas.microsoft.com/office/drawing/2014/main" val="2811371679"/>
                    </a:ext>
                  </a:extLst>
                </a:gridCol>
                <a:gridCol w="561386">
                  <a:extLst>
                    <a:ext uri="{9D8B030D-6E8A-4147-A177-3AD203B41FA5}">
                      <a16:colId xmlns:a16="http://schemas.microsoft.com/office/drawing/2014/main" val="838383813"/>
                    </a:ext>
                  </a:extLst>
                </a:gridCol>
                <a:gridCol w="1309902">
                  <a:extLst>
                    <a:ext uri="{9D8B030D-6E8A-4147-A177-3AD203B41FA5}">
                      <a16:colId xmlns:a16="http://schemas.microsoft.com/office/drawing/2014/main" val="550570641"/>
                    </a:ext>
                  </a:extLst>
                </a:gridCol>
                <a:gridCol w="622788">
                  <a:extLst>
                    <a:ext uri="{9D8B030D-6E8A-4147-A177-3AD203B41FA5}">
                      <a16:colId xmlns:a16="http://schemas.microsoft.com/office/drawing/2014/main" val="480602176"/>
                    </a:ext>
                  </a:extLst>
                </a:gridCol>
                <a:gridCol w="818689">
                  <a:extLst>
                    <a:ext uri="{9D8B030D-6E8A-4147-A177-3AD203B41FA5}">
                      <a16:colId xmlns:a16="http://schemas.microsoft.com/office/drawing/2014/main" val="2959360587"/>
                    </a:ext>
                  </a:extLst>
                </a:gridCol>
                <a:gridCol w="830384">
                  <a:extLst>
                    <a:ext uri="{9D8B030D-6E8A-4147-A177-3AD203B41FA5}">
                      <a16:colId xmlns:a16="http://schemas.microsoft.com/office/drawing/2014/main" val="3448653394"/>
                    </a:ext>
                  </a:extLst>
                </a:gridCol>
                <a:gridCol w="868395">
                  <a:extLst>
                    <a:ext uri="{9D8B030D-6E8A-4147-A177-3AD203B41FA5}">
                      <a16:colId xmlns:a16="http://schemas.microsoft.com/office/drawing/2014/main" val="3569268386"/>
                    </a:ext>
                  </a:extLst>
                </a:gridCol>
              </a:tblGrid>
              <a:tr h="35138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agnosis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btype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utations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gb (GM/DL)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BC (X10^3/ML)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lts (X10^3/ML)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genetics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5270443"/>
                  </a:ext>
                </a:extLst>
              </a:tr>
              <a:tr h="17745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DS1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 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, TET2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0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ML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8232797"/>
                  </a:ext>
                </a:extLst>
              </a:tr>
              <a:tr h="5270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DS2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EB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, RUNX1, BCOR, NRAS, DNMT3A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13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1489808"/>
                  </a:ext>
                </a:extLst>
              </a:tr>
              <a:tr h="35138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DS3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CMD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, IDH1, JAK2, KRAS, TET2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ML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5870609"/>
                  </a:ext>
                </a:extLst>
              </a:tr>
              <a:tr h="17745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DS4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CMD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, TET2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0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l(5q) 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215370"/>
                  </a:ext>
                </a:extLst>
              </a:tr>
              <a:tr h="17745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DS5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CMD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ML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2636858"/>
                  </a:ext>
                </a:extLst>
              </a:tr>
              <a:tr h="35138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DS6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CMD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, TET2, GNAS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0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ML</a:t>
                      </a:r>
                    </a:p>
                  </a:txBody>
                  <a:tcPr marL="8785" marR="8785" marT="87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60098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545995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247</TotalTime>
  <Words>98</Words>
  <Application>Microsoft Office PowerPoint</Application>
  <PresentationFormat>On-screen Show (4:3)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ry File 1: Patient sampl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Gaurav Choudhary</cp:lastModifiedBy>
  <cp:revision>315</cp:revision>
  <cp:lastPrinted>2021-12-21T15:05:07Z</cp:lastPrinted>
  <dcterms:created xsi:type="dcterms:W3CDTF">2019-12-11T18:30:18Z</dcterms:created>
  <dcterms:modified xsi:type="dcterms:W3CDTF">2022-07-06T17:26:03Z</dcterms:modified>
</cp:coreProperties>
</file>